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752" autoAdjust="0"/>
    <p:restoredTop sz="94660"/>
  </p:normalViewPr>
  <p:slideViewPr>
    <p:cSldViewPr snapToGrid="0">
      <p:cViewPr varScale="1">
        <p:scale>
          <a:sx n="57" d="100"/>
          <a:sy n="57" d="100"/>
        </p:scale>
        <p:origin x="87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845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60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753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07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759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047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96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901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58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557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72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678C4-1922-4591-B169-C29C26B02705}" type="datetimeFigureOut">
              <a:rPr kumimoji="1" lang="ja-JP" altLang="en-US" smtClean="0"/>
              <a:t>2020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5929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image" Target="../media/image17.png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" Type="http://schemas.openxmlformats.org/officeDocument/2006/relationships/image" Target="../media/image33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5" Type="http://schemas.openxmlformats.org/officeDocument/2006/relationships/image" Target="../media/image4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1656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4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3024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60"/>
          <p:cNvSpPr>
            <a:spLocks noChangeArrowheads="1"/>
          </p:cNvSpPr>
          <p:nvPr/>
        </p:nvSpPr>
        <p:spPr bwMode="auto">
          <a:xfrm rot="5400000">
            <a:off x="6228000" y="439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6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60"/>
          <p:cNvSpPr>
            <a:spLocks noChangeArrowheads="1"/>
          </p:cNvSpPr>
          <p:nvPr/>
        </p:nvSpPr>
        <p:spPr bwMode="auto">
          <a:xfrm rot="5400000">
            <a:off x="6228000" y="5760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6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1152000"/>
            <a:ext cx="1924050" cy="2095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1152000"/>
            <a:ext cx="1924050" cy="2095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1152000"/>
            <a:ext cx="1924050" cy="2095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1152000"/>
            <a:ext cx="1924050" cy="2095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095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095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095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0955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3888000"/>
            <a:ext cx="1924050" cy="2095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3888000"/>
            <a:ext cx="1924050" cy="2095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3888000"/>
            <a:ext cx="1924050" cy="2095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3888000"/>
            <a:ext cx="1924050" cy="2095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5256000"/>
            <a:ext cx="1924050" cy="2095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5256000"/>
            <a:ext cx="1924050" cy="2095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5256000"/>
            <a:ext cx="1924050" cy="2095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5256000"/>
            <a:ext cx="1924050" cy="2095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2918496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538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1656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4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3024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60"/>
          <p:cNvSpPr>
            <a:spLocks noChangeArrowheads="1"/>
          </p:cNvSpPr>
          <p:nvPr/>
        </p:nvSpPr>
        <p:spPr bwMode="auto">
          <a:xfrm rot="5400000">
            <a:off x="6228000" y="439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6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60"/>
          <p:cNvSpPr>
            <a:spLocks noChangeArrowheads="1"/>
          </p:cNvSpPr>
          <p:nvPr/>
        </p:nvSpPr>
        <p:spPr bwMode="auto">
          <a:xfrm rot="5400000">
            <a:off x="6228000" y="5760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9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1152000"/>
            <a:ext cx="1924050" cy="2095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1152000"/>
            <a:ext cx="1924050" cy="2095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1152000"/>
            <a:ext cx="1924050" cy="2095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1152000"/>
            <a:ext cx="1924050" cy="2095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095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095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095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0955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3888000"/>
            <a:ext cx="1924050" cy="2095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3888000"/>
            <a:ext cx="1924050" cy="2095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3888000"/>
            <a:ext cx="1924050" cy="2095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3888000"/>
            <a:ext cx="1924050" cy="2095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5256000"/>
            <a:ext cx="1924050" cy="2095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5256000"/>
            <a:ext cx="1924050" cy="2095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5256000"/>
            <a:ext cx="1924050" cy="2095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5256000"/>
            <a:ext cx="1924050" cy="2095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2918496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5925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60"/>
          <p:cNvSpPr>
            <a:spLocks noChangeArrowheads="1"/>
          </p:cNvSpPr>
          <p:nvPr/>
        </p:nvSpPr>
        <p:spPr bwMode="auto">
          <a:xfrm>
            <a:off x="24084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60"/>
          <p:cNvSpPr>
            <a:spLocks noChangeArrowheads="1"/>
          </p:cNvSpPr>
          <p:nvPr/>
        </p:nvSpPr>
        <p:spPr bwMode="auto">
          <a:xfrm>
            <a:off x="3906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60"/>
          <p:cNvSpPr>
            <a:spLocks noChangeArrowheads="1"/>
          </p:cNvSpPr>
          <p:nvPr/>
        </p:nvSpPr>
        <p:spPr bwMode="auto">
          <a:xfrm>
            <a:off x="540000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60"/>
          <p:cNvSpPr>
            <a:spLocks noChangeArrowheads="1"/>
          </p:cNvSpPr>
          <p:nvPr/>
        </p:nvSpPr>
        <p:spPr bwMode="auto">
          <a:xfrm>
            <a:off x="923760" y="90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1656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4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3024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60"/>
          <p:cNvSpPr>
            <a:spLocks noChangeArrowheads="1"/>
          </p:cNvSpPr>
          <p:nvPr/>
        </p:nvSpPr>
        <p:spPr bwMode="auto">
          <a:xfrm rot="5400000">
            <a:off x="6228000" y="439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6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60"/>
          <p:cNvSpPr>
            <a:spLocks noChangeArrowheads="1"/>
          </p:cNvSpPr>
          <p:nvPr/>
        </p:nvSpPr>
        <p:spPr bwMode="auto">
          <a:xfrm rot="5400000">
            <a:off x="6228000" y="5760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1152000"/>
            <a:ext cx="1924050" cy="2095500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1152000"/>
            <a:ext cx="1924050" cy="2095500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1152000"/>
            <a:ext cx="1924050" cy="2095500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1152000"/>
            <a:ext cx="1924050" cy="2095500"/>
          </a:xfrm>
          <a:prstGeom prst="rect">
            <a:avLst/>
          </a:prstGeom>
        </p:spPr>
      </p:pic>
      <p:pic>
        <p:nvPicPr>
          <p:cNvPr id="38" name="図 3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095500"/>
          </a:xfrm>
          <a:prstGeom prst="rect">
            <a:avLst/>
          </a:prstGeom>
        </p:spPr>
      </p:pic>
      <p:pic>
        <p:nvPicPr>
          <p:cNvPr id="39" name="図 3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095500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095500"/>
          </a:xfrm>
          <a:prstGeom prst="rect">
            <a:avLst/>
          </a:prstGeom>
        </p:spPr>
      </p:pic>
      <p:pic>
        <p:nvPicPr>
          <p:cNvPr id="41" name="図 4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0955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3888000"/>
            <a:ext cx="1924050" cy="2095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3888000"/>
            <a:ext cx="1924050" cy="2095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3888000"/>
            <a:ext cx="1924050" cy="2095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3888000"/>
            <a:ext cx="1924050" cy="2095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5256000"/>
            <a:ext cx="1924050" cy="2095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5256000"/>
            <a:ext cx="1924050" cy="2095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5256000"/>
            <a:ext cx="1924050" cy="2095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5256000"/>
            <a:ext cx="1924050" cy="2095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2918496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2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4831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4</TotalTime>
  <Words>102</Words>
  <Application>Microsoft Office PowerPoint</Application>
  <PresentationFormat>A4 210 x 297 mm</PresentationFormat>
  <Paragraphs>3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2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　幸二</dc:creator>
  <cp:lastModifiedBy>kadota</cp:lastModifiedBy>
  <cp:revision>35</cp:revision>
  <dcterms:created xsi:type="dcterms:W3CDTF">2020-06-11T23:59:28Z</dcterms:created>
  <dcterms:modified xsi:type="dcterms:W3CDTF">2020-08-28T06:53:12Z</dcterms:modified>
</cp:coreProperties>
</file>